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772400" cy="100584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EAF4B25-D7FA-4EB6-A840-B88ED06FD8E0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828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931FA1C-019A-47E4-A395-44F9C09ABA9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82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3520" y="39682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8469811-7240-4331-8785-B1848ACCA9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280" y="16048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1360" y="16048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82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280" y="39682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1360" y="39682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0B3683A-0117-4603-AAAC-CC614F0BF0BC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488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F560CD23-0339-4BDB-B354-8EE8098A495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F0CE810-0BC1-4CE7-B06F-19CD7A6D96B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8CA9833-E09E-4F7E-8413-86BA65FF840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1BD71B7-AC53-4CB4-96FD-A96069D7842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2520"/>
            <a:ext cx="822816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06F5BA2-8910-49AA-AEA1-58F762F83A9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82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3067CF9-69AF-4AA1-A367-D77543F7FF4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3520" y="39682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6B467E9-BF04-47EA-BADF-76EAF3F4EAF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828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CDDFB42-3D06-48EA-BF64-FC135217801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dt" idx="1"/>
          </p:nvPr>
        </p:nvSpPr>
        <p:spPr>
          <a:xfrm>
            <a:off x="457200" y="6356160"/>
            <a:ext cx="2131920" cy="3632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10/13/1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"/>
          <p:cNvSpPr/>
          <p:nvPr/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2"/>
          <p:cNvSpPr>
            <a:spLocks noGrp="1"/>
          </p:cNvSpPr>
          <p:nvPr>
            <p:ph type="sldNum" idx="2"/>
          </p:nvPr>
        </p:nvSpPr>
        <p:spPr>
          <a:xfrm>
            <a:off x="6552720" y="6356160"/>
            <a:ext cx="2132280" cy="3632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5B009160-A0C5-4419-B6FD-9F875D650B1A}" type="slidenum">
              <a:rPr b="0" lang="en-US" sz="18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3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body"/>
          </p:nvPr>
        </p:nvSpPr>
        <p:spPr>
          <a:xfrm>
            <a:off x="457200" y="160488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99000"/>
          </a:bodyPr>
          <a:p>
            <a:pPr marL="339480" indent="0">
              <a:lnSpc>
                <a:spcPct val="102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339480" indent="-3394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339480" indent="-3394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339480" indent="-3394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339480" indent="-3394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339480" indent="-3394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339480" indent="-3394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1344600" y="336600"/>
            <a:ext cx="6039000" cy="487368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347400" y="5487840"/>
            <a:ext cx="7623720" cy="960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dditional file 2: Figure S1. No correlation between perivascular CD4 infiltration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nd DLCO, p=0.642,r=-0.064</a:t>
            </a: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/>
  <cp:revision>0</cp:revision>
  <dc:subject/>
  <dc:title/>
</cp:coreProperties>
</file>